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5" r:id="rId2"/>
    <p:sldId id="300" r:id="rId3"/>
    <p:sldId id="306" r:id="rId4"/>
    <p:sldId id="301" r:id="rId5"/>
    <p:sldId id="307" r:id="rId6"/>
    <p:sldId id="302" r:id="rId7"/>
    <p:sldId id="308" r:id="rId8"/>
    <p:sldId id="303" r:id="rId9"/>
    <p:sldId id="309" r:id="rId10"/>
    <p:sldId id="304" r:id="rId11"/>
    <p:sldId id="310" r:id="rId1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564" autoAdjust="0"/>
  </p:normalViewPr>
  <p:slideViewPr>
    <p:cSldViewPr>
      <p:cViewPr varScale="1">
        <p:scale>
          <a:sx n="156" d="100"/>
          <a:sy n="156" d="100"/>
        </p:scale>
        <p:origin x="-224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1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6175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1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4598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1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985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1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7248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1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40398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1.08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63206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1.08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153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1.08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7145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1.08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15543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1.08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41420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F0DC2-802A-439E-B69F-5C71B2100713}" type="datetimeFigureOut">
              <a:rPr lang="de-DE" smtClean="0"/>
              <a:t>11.08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0479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EF0DC2-802A-439E-B69F-5C71B2100713}" type="datetimeFigureOut">
              <a:rPr lang="de-DE" smtClean="0"/>
              <a:t>11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2E96A5-D4DB-448D-B60B-18D0EE4C470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2889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457200" y="304800"/>
            <a:ext cx="890912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000" dirty="0" smtClean="0"/>
              <a:t>S2: Fitted curves, estimated parameters and simulations</a:t>
            </a:r>
            <a:endParaRPr lang="en-GB" sz="4000" dirty="0"/>
          </a:p>
        </p:txBody>
      </p:sp>
      <p:graphicFrame>
        <p:nvGraphicFramePr>
          <p:cNvPr id="3" name="Tabel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26658773"/>
              </p:ext>
            </p:extLst>
          </p:nvPr>
        </p:nvGraphicFramePr>
        <p:xfrm>
          <a:off x="676290" y="2057400"/>
          <a:ext cx="8239110" cy="3337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47732"/>
                <a:gridCol w="2028430"/>
                <a:gridCol w="4262948"/>
              </a:tblGrid>
              <a:tr h="370840">
                <a:tc>
                  <a:txBody>
                    <a:bodyPr/>
                    <a:lstStyle/>
                    <a:p>
                      <a:r>
                        <a:rPr lang="de-DE" dirty="0" smtClean="0"/>
                        <a:t>Variable</a:t>
                      </a:r>
                      <a:endParaRPr lang="de-DE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 err="1" smtClean="0"/>
                        <a:t>units</a:t>
                      </a:r>
                      <a:endParaRPr lang="de-DE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 smtClean="0"/>
                        <a:t>Description</a:t>
                      </a:r>
                      <a:endParaRPr lang="de-DE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R</a:t>
                      </a:r>
                      <a:r>
                        <a:rPr lang="en-US" sz="18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,0</a:t>
                      </a: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8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ol</a:t>
                      </a: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L]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inding site density</a:t>
                      </a:r>
                      <a:r>
                        <a:rPr lang="en-GB" sz="1800" kern="1200" baseline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baseline="0" dirty="0" err="1" smtClean="0"/>
                        <a:t>salivary</a:t>
                      </a:r>
                      <a:r>
                        <a:rPr lang="de-DE" baseline="0" dirty="0" smtClean="0"/>
                        <a:t> (</a:t>
                      </a:r>
                      <a:r>
                        <a:rPr lang="de-DE" baseline="0" dirty="0" err="1" smtClean="0"/>
                        <a:t>parotid</a:t>
                      </a:r>
                      <a:r>
                        <a:rPr lang="de-DE" baseline="0" dirty="0" smtClean="0"/>
                        <a:t>) </a:t>
                      </a:r>
                      <a:r>
                        <a:rPr lang="de-DE" baseline="0" dirty="0" err="1" smtClean="0"/>
                        <a:t>glands</a:t>
                      </a:r>
                      <a:endParaRPr lang="de-DE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R</a:t>
                      </a:r>
                      <a:r>
                        <a:rPr lang="en-US" sz="18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,0</a:t>
                      </a: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8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ol</a:t>
                      </a: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L]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inding site </a:t>
                      </a:r>
                      <a:r>
                        <a:rPr lang="de-DE" baseline="0" dirty="0" err="1" smtClean="0"/>
                        <a:t>density</a:t>
                      </a:r>
                      <a:r>
                        <a:rPr lang="de-DE" baseline="0" dirty="0" smtClean="0"/>
                        <a:t> </a:t>
                      </a:r>
                      <a:r>
                        <a:rPr lang="de-DE" baseline="0" dirty="0" err="1" smtClean="0"/>
                        <a:t>kidneys</a:t>
                      </a:r>
                      <a:endParaRPr lang="de-DE" dirty="0" smtClean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R</a:t>
                      </a:r>
                      <a:r>
                        <a:rPr lang="en-US" sz="18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,0</a:t>
                      </a: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8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ol</a:t>
                      </a: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L]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inding site </a:t>
                      </a:r>
                      <a:r>
                        <a:rPr lang="de-DE" baseline="0" dirty="0" err="1" smtClean="0"/>
                        <a:t>density</a:t>
                      </a:r>
                      <a:r>
                        <a:rPr lang="de-DE" baseline="0" dirty="0" smtClean="0"/>
                        <a:t> </a:t>
                      </a:r>
                      <a:r>
                        <a:rPr lang="de-DE" baseline="0" dirty="0" err="1" smtClean="0"/>
                        <a:t>tumor</a:t>
                      </a:r>
                      <a:endParaRPr lang="de-DE" dirty="0" smtClean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de-DE" dirty="0" smtClean="0"/>
                        <a:t>c</a:t>
                      </a:r>
                      <a:endParaRPr lang="de-DE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unity]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 smtClean="0"/>
                        <a:t>Background</a:t>
                      </a:r>
                      <a:r>
                        <a:rPr lang="de-DE" baseline="0" dirty="0" smtClean="0"/>
                        <a:t> </a:t>
                      </a:r>
                      <a:r>
                        <a:rPr lang="de-DE" baseline="0" dirty="0" err="1" smtClean="0"/>
                        <a:t>correction</a:t>
                      </a:r>
                      <a:r>
                        <a:rPr lang="de-DE" baseline="0" dirty="0" smtClean="0"/>
                        <a:t>*</a:t>
                      </a:r>
                      <a:endParaRPr lang="de-DE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800" baseline="-250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,release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min</a:t>
                      </a:r>
                      <a:r>
                        <a:rPr lang="en-US" sz="1800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dirty="0" smtClean="0"/>
                        <a:t>Release</a:t>
                      </a:r>
                      <a:r>
                        <a:rPr lang="de-DE" baseline="0" dirty="0" smtClean="0"/>
                        <a:t> rate </a:t>
                      </a:r>
                      <a:r>
                        <a:rPr lang="de-DE" baseline="0" dirty="0" err="1" smtClean="0"/>
                        <a:t>salivary</a:t>
                      </a:r>
                      <a:r>
                        <a:rPr lang="de-DE" baseline="0" dirty="0" smtClean="0"/>
                        <a:t> (</a:t>
                      </a:r>
                      <a:r>
                        <a:rPr lang="de-DE" baseline="0" dirty="0" err="1" smtClean="0"/>
                        <a:t>parotid</a:t>
                      </a:r>
                      <a:r>
                        <a:rPr lang="de-DE" baseline="0" dirty="0" smtClean="0"/>
                        <a:t>) </a:t>
                      </a:r>
                      <a:r>
                        <a:rPr lang="de-DE" baseline="0" dirty="0" err="1" smtClean="0"/>
                        <a:t>glands</a:t>
                      </a:r>
                      <a:endParaRPr lang="de-DE" dirty="0" smtClean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8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,release</a:t>
                      </a: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min</a:t>
                      </a:r>
                      <a:r>
                        <a:rPr lang="en-US" sz="1800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 smtClean="0"/>
                        <a:t>Release</a:t>
                      </a:r>
                      <a:r>
                        <a:rPr lang="de-DE" baseline="0" dirty="0" smtClean="0"/>
                        <a:t> rate </a:t>
                      </a:r>
                      <a:r>
                        <a:rPr lang="de-DE" baseline="0" dirty="0" err="1" smtClean="0"/>
                        <a:t>kidneys</a:t>
                      </a:r>
                      <a:endParaRPr lang="de-DE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800" baseline="-250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,release</a:t>
                      </a: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min</a:t>
                      </a:r>
                      <a:r>
                        <a:rPr lang="en-US" sz="1800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r>
                        <a:rPr lang="en-US" sz="1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8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 smtClean="0"/>
                        <a:t>Release</a:t>
                      </a:r>
                      <a:r>
                        <a:rPr lang="de-DE" baseline="0" dirty="0" smtClean="0"/>
                        <a:t> rate </a:t>
                      </a:r>
                      <a:r>
                        <a:rPr lang="de-DE" baseline="0" dirty="0" err="1" smtClean="0"/>
                        <a:t>tumor</a:t>
                      </a:r>
                      <a:endParaRPr lang="de-DE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r>
                        <a:rPr lang="de-DE" sz="1800" baseline="-25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AL</a:t>
                      </a:r>
                      <a:endParaRPr lang="en-US" sz="18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[ml/g/min]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baseline="0" dirty="0" smtClean="0"/>
                        <a:t>Perfusion </a:t>
                      </a:r>
                      <a:r>
                        <a:rPr lang="de-DE" baseline="0" dirty="0" err="1" smtClean="0"/>
                        <a:t>salivary</a:t>
                      </a:r>
                      <a:r>
                        <a:rPr lang="de-DE" baseline="0" dirty="0" smtClean="0"/>
                        <a:t> (</a:t>
                      </a:r>
                      <a:r>
                        <a:rPr lang="de-DE" baseline="0" dirty="0" err="1" smtClean="0"/>
                        <a:t>parotid</a:t>
                      </a:r>
                      <a:r>
                        <a:rPr lang="de-DE" baseline="0" dirty="0" smtClean="0"/>
                        <a:t>) </a:t>
                      </a:r>
                      <a:r>
                        <a:rPr lang="de-DE" baseline="0" dirty="0" err="1" smtClean="0"/>
                        <a:t>glands</a:t>
                      </a:r>
                      <a:endParaRPr lang="de-DE" dirty="0" smtClean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609600" y="5562600"/>
            <a:ext cx="821058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*</a:t>
            </a:r>
            <a:r>
              <a:rPr lang="de-DE" sz="1600" dirty="0" err="1" smtClean="0"/>
              <a:t>Especially</a:t>
            </a:r>
            <a:r>
              <a:rPr lang="de-DE" sz="1600" dirty="0" smtClean="0"/>
              <a:t> </a:t>
            </a:r>
            <a:r>
              <a:rPr lang="de-DE" sz="1600" dirty="0" err="1" smtClean="0"/>
              <a:t>for</a:t>
            </a:r>
            <a:r>
              <a:rPr lang="de-DE" sz="1600" dirty="0" smtClean="0"/>
              <a:t> </a:t>
            </a:r>
            <a:r>
              <a:rPr lang="de-DE" sz="1600" dirty="0" err="1" smtClean="0"/>
              <a:t>small</a:t>
            </a:r>
            <a:r>
              <a:rPr lang="de-DE" sz="1600" dirty="0" smtClean="0"/>
              <a:t> </a:t>
            </a:r>
            <a:r>
              <a:rPr lang="de-DE" sz="1600" dirty="0" err="1" smtClean="0"/>
              <a:t>tumor</a:t>
            </a:r>
            <a:r>
              <a:rPr lang="de-DE" sz="1600" dirty="0" smtClean="0"/>
              <a:t> </a:t>
            </a:r>
            <a:r>
              <a:rPr lang="de-DE" sz="1600" dirty="0" err="1" smtClean="0"/>
              <a:t>lesions</a:t>
            </a:r>
            <a:r>
              <a:rPr lang="de-DE" sz="1600" dirty="0" smtClean="0"/>
              <a:t>, </a:t>
            </a:r>
            <a:r>
              <a:rPr lang="de-DE" sz="1600" dirty="0" err="1" smtClean="0"/>
              <a:t>the</a:t>
            </a:r>
            <a:r>
              <a:rPr lang="de-DE" sz="1600" dirty="0" smtClean="0"/>
              <a:t> </a:t>
            </a:r>
            <a:r>
              <a:rPr lang="de-DE" sz="1600" dirty="0" err="1" smtClean="0"/>
              <a:t>diameter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</a:t>
            </a:r>
            <a:r>
              <a:rPr lang="de-DE" sz="1600" dirty="0" err="1" smtClean="0"/>
              <a:t>the</a:t>
            </a:r>
            <a:r>
              <a:rPr lang="de-DE" sz="1600" dirty="0" smtClean="0"/>
              <a:t> ROI was larger </a:t>
            </a:r>
            <a:r>
              <a:rPr lang="de-DE" sz="1600" dirty="0" err="1" smtClean="0"/>
              <a:t>than</a:t>
            </a:r>
            <a:r>
              <a:rPr lang="de-DE" sz="1600" dirty="0" smtClean="0"/>
              <a:t> </a:t>
            </a:r>
            <a:r>
              <a:rPr lang="de-DE" sz="1600" dirty="0" err="1" smtClean="0"/>
              <a:t>the</a:t>
            </a:r>
            <a:r>
              <a:rPr lang="de-DE" sz="1600" dirty="0" smtClean="0"/>
              <a:t> </a:t>
            </a:r>
            <a:r>
              <a:rPr lang="de-DE" sz="1600" dirty="0" err="1" smtClean="0"/>
              <a:t>tumor</a:t>
            </a:r>
            <a:endParaRPr lang="de-DE" sz="1600" dirty="0" smtClean="0"/>
          </a:p>
          <a:p>
            <a:r>
              <a:rPr lang="de-DE" sz="1600" dirty="0" err="1" smtClean="0"/>
              <a:t>diameter</a:t>
            </a:r>
            <a:r>
              <a:rPr lang="de-DE" sz="1600" dirty="0"/>
              <a:t>.</a:t>
            </a:r>
            <a:r>
              <a:rPr lang="de-DE" sz="1600" dirty="0" smtClean="0"/>
              <a:t> </a:t>
            </a:r>
            <a:r>
              <a:rPr lang="de-DE" sz="1600" dirty="0" err="1" smtClean="0"/>
              <a:t>Although</a:t>
            </a:r>
            <a:r>
              <a:rPr lang="de-DE" sz="1600" dirty="0" smtClean="0"/>
              <a:t> </a:t>
            </a:r>
            <a:r>
              <a:rPr lang="de-DE" sz="1600" dirty="0" err="1" smtClean="0"/>
              <a:t>background</a:t>
            </a:r>
            <a:r>
              <a:rPr lang="de-DE" sz="1600" dirty="0" smtClean="0"/>
              <a:t> </a:t>
            </a:r>
            <a:r>
              <a:rPr lang="de-DE" sz="1600" dirty="0" err="1" smtClean="0"/>
              <a:t>correction</a:t>
            </a:r>
            <a:r>
              <a:rPr lang="de-DE" sz="1600" dirty="0" smtClean="0"/>
              <a:t> was </a:t>
            </a:r>
            <a:r>
              <a:rPr lang="de-DE" sz="1600" dirty="0" err="1" smtClean="0"/>
              <a:t>applied</a:t>
            </a:r>
            <a:r>
              <a:rPr lang="de-DE" sz="1600" dirty="0"/>
              <a:t> </a:t>
            </a:r>
            <a:r>
              <a:rPr lang="de-DE" sz="1600" dirty="0" smtClean="0"/>
              <a:t>an additional </a:t>
            </a:r>
            <a:r>
              <a:rPr lang="de-DE" sz="1600" dirty="0" err="1" smtClean="0"/>
              <a:t>correction</a:t>
            </a:r>
            <a:r>
              <a:rPr lang="de-DE" sz="1600" dirty="0" smtClean="0"/>
              <a:t> was </a:t>
            </a:r>
            <a:r>
              <a:rPr lang="de-DE" sz="1600" dirty="0" err="1" smtClean="0"/>
              <a:t>necessary</a:t>
            </a:r>
            <a:r>
              <a:rPr lang="de-DE" sz="1600" dirty="0" smtClean="0"/>
              <a:t>. </a:t>
            </a:r>
          </a:p>
          <a:p>
            <a:r>
              <a:rPr lang="de-DE" sz="1600" dirty="0" err="1" smtClean="0"/>
              <a:t>ROI</a:t>
            </a:r>
            <a:r>
              <a:rPr lang="de-DE" sz="1600" baseline="-25000" dirty="0" err="1" smtClean="0"/>
              <a:t>Tumor</a:t>
            </a:r>
            <a:r>
              <a:rPr lang="de-DE" sz="1600" dirty="0" smtClean="0"/>
              <a:t> = c ∙ </a:t>
            </a:r>
            <a:r>
              <a:rPr lang="de-DE" sz="1600" dirty="0" err="1" smtClean="0"/>
              <a:t>muscle</a:t>
            </a:r>
            <a:r>
              <a:rPr lang="de-DE" sz="1600" dirty="0" smtClean="0"/>
              <a:t> + </a:t>
            </a:r>
            <a:r>
              <a:rPr lang="de-DE" sz="1600" dirty="0" err="1" smtClean="0"/>
              <a:t>tumor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24221933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612345"/>
              </p:ext>
            </p:extLst>
          </p:nvPr>
        </p:nvGraphicFramePr>
        <p:xfrm>
          <a:off x="1080000" y="468000"/>
          <a:ext cx="6900950" cy="81153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37803"/>
                <a:gridCol w="598091"/>
                <a:gridCol w="531416"/>
                <a:gridCol w="640953"/>
                <a:gridCol w="602853"/>
                <a:gridCol w="767953"/>
                <a:gridCol w="648891"/>
                <a:gridCol w="744141"/>
                <a:gridCol w="758428"/>
                <a:gridCol w="311479"/>
                <a:gridCol w="458942"/>
              </a:tblGrid>
              <a:tr h="2286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ameter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1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2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l-GR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100" baseline="-250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,releas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,releas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100" baseline="-250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,release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r>
                        <a:rPr lang="de-DE" sz="1100" baseline="-25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AL</a:t>
                      </a:r>
                      <a:endParaRPr lang="de-DE" sz="110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baseline="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  <a:endParaRPr lang="de-DE" sz="110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de-DE" sz="1100" baseline="-25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de-DE" sz="110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</a:tr>
              <a:tr h="2286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nit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gridSpan="4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ol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L]</a:t>
                      </a:r>
                      <a:endParaRPr lang="de-DE" sz="11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gridSpan="3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min</a:t>
                      </a:r>
                      <a:r>
                        <a:rPr lang="en-US" sz="1100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·10</a:t>
                      </a:r>
                      <a:r>
                        <a:rPr lang="en-US" sz="1100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1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[ml/g/min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grid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de-DE" sz="1100" dirty="0" err="1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nity</a:t>
                      </a: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]</a:t>
                      </a: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</a:tr>
              <a:tr h="1682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err="1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stimat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.18</a:t>
                      </a:r>
                      <a:r>
                        <a:rPr lang="de-DE" sz="1100" dirty="0" smtClean="0"/>
                        <a:t> 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8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5440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V [%]</a:t>
                      </a:r>
                      <a:endParaRPr lang="de-DE" sz="11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4" name="Textfeld 3"/>
          <p:cNvSpPr txBox="1"/>
          <p:nvPr/>
        </p:nvSpPr>
        <p:spPr>
          <a:xfrm>
            <a:off x="360000" y="360000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5</a:t>
            </a:r>
            <a:endParaRPr lang="de-DE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6400" y="1600200"/>
            <a:ext cx="5544312" cy="49499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26489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360000" y="360000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5</a:t>
            </a:r>
            <a:endParaRPr lang="de-DE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00" y="720000"/>
            <a:ext cx="8640000" cy="6127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07839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el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3263985"/>
              </p:ext>
            </p:extLst>
          </p:nvPr>
        </p:nvGraphicFramePr>
        <p:xfrm>
          <a:off x="1080000" y="468000"/>
          <a:ext cx="6953717" cy="81153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37803"/>
                <a:gridCol w="598091"/>
                <a:gridCol w="486186"/>
                <a:gridCol w="601143"/>
                <a:gridCol w="602853"/>
                <a:gridCol w="767953"/>
                <a:gridCol w="648891"/>
                <a:gridCol w="744141"/>
                <a:gridCol w="758428"/>
                <a:gridCol w="381158"/>
                <a:gridCol w="527070"/>
              </a:tblGrid>
              <a:tr h="2286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ameter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1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2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l-GR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100" baseline="-250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,releas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,releas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100" baseline="-250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,release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r>
                        <a:rPr lang="de-DE" sz="1100" baseline="-25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AL</a:t>
                      </a:r>
                      <a:endParaRPr lang="de-DE" sz="110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baseline="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  <a:endParaRPr lang="de-DE" sz="110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de-DE" sz="1100" baseline="-25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de-DE" sz="110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</a:tr>
              <a:tr h="2286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nit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gridSpan="4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ol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L]</a:t>
                      </a:r>
                      <a:endParaRPr lang="de-DE" sz="11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gridSpan="3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min</a:t>
                      </a:r>
                      <a:r>
                        <a:rPr lang="en-US" sz="1100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·10</a:t>
                      </a:r>
                      <a:r>
                        <a:rPr lang="en-US" sz="1100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1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[ml/g/min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de-DE" sz="1100" dirty="0" err="1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nity</a:t>
                      </a: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</a:tr>
              <a:tr h="1682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err="1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stimat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.075</a:t>
                      </a:r>
                      <a:r>
                        <a:rPr lang="de-DE" sz="1100" dirty="0" smtClean="0"/>
                        <a:t> 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5440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V [%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9" name="Textfeld 8"/>
          <p:cNvSpPr txBox="1"/>
          <p:nvPr/>
        </p:nvSpPr>
        <p:spPr>
          <a:xfrm>
            <a:off x="360000" y="360000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1</a:t>
            </a:r>
            <a:endParaRPr lang="de-DE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600" y="1905000"/>
            <a:ext cx="5440680" cy="41056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70443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360000" y="360000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1</a:t>
            </a:r>
            <a:endParaRPr lang="de-DE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00" y="720000"/>
            <a:ext cx="8640000" cy="6127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29860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316914"/>
              </p:ext>
            </p:extLst>
          </p:nvPr>
        </p:nvGraphicFramePr>
        <p:xfrm>
          <a:off x="1080000" y="468000"/>
          <a:ext cx="6930103" cy="81153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37803"/>
                <a:gridCol w="598091"/>
                <a:gridCol w="480433"/>
                <a:gridCol w="594030"/>
                <a:gridCol w="602853"/>
                <a:gridCol w="767953"/>
                <a:gridCol w="648891"/>
                <a:gridCol w="744141"/>
                <a:gridCol w="758428"/>
                <a:gridCol w="448740"/>
                <a:gridCol w="448740"/>
              </a:tblGrid>
              <a:tr h="2286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ameter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1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2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l-GR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100" baseline="-250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,releas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,releas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100" baseline="-250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,release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r>
                        <a:rPr lang="de-DE" sz="1100" baseline="-25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AL</a:t>
                      </a:r>
                      <a:endParaRPr lang="de-DE" sz="110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baseline="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  <a:endParaRPr lang="de-DE" sz="110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de-DE" sz="1100" baseline="-25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de-DE" sz="110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</a:tr>
              <a:tr h="2286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nit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gridSpan="4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ol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L]</a:t>
                      </a:r>
                      <a:endParaRPr lang="de-DE" sz="11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gridSpan="3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min</a:t>
                      </a:r>
                      <a:r>
                        <a:rPr lang="en-US" sz="1100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·10</a:t>
                      </a:r>
                      <a:r>
                        <a:rPr lang="en-US" sz="1100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1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[ml/g/min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grid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de-DE" sz="1100" dirty="0" err="1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nity</a:t>
                      </a: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]</a:t>
                      </a: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</a:tr>
              <a:tr h="1682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err="1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stimat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.074</a:t>
                      </a:r>
                      <a:r>
                        <a:rPr lang="de-DE" sz="1100" dirty="0" smtClean="0"/>
                        <a:t> 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6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5440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V [%]</a:t>
                      </a:r>
                      <a:endParaRPr lang="de-DE" sz="11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360000" y="360000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2</a:t>
            </a:r>
            <a:endParaRPr lang="de-DE" dirty="0"/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00" y="1752600"/>
            <a:ext cx="5425440" cy="48585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53411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360000" y="360000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2</a:t>
            </a:r>
            <a:endParaRPr lang="de-DE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00" y="720000"/>
            <a:ext cx="8640000" cy="6127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72654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0346518"/>
              </p:ext>
            </p:extLst>
          </p:nvPr>
        </p:nvGraphicFramePr>
        <p:xfrm>
          <a:off x="1080000" y="468000"/>
          <a:ext cx="6687006" cy="81153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37803"/>
                <a:gridCol w="598091"/>
                <a:gridCol w="491113"/>
                <a:gridCol w="607235"/>
                <a:gridCol w="571140"/>
                <a:gridCol w="767953"/>
                <a:gridCol w="614756"/>
                <a:gridCol w="744141"/>
                <a:gridCol w="758428"/>
                <a:gridCol w="311325"/>
                <a:gridCol w="385021"/>
              </a:tblGrid>
              <a:tr h="2286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ameter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1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2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l-GR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100" baseline="-250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,releas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,releas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100" baseline="-250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,release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r>
                        <a:rPr lang="de-DE" sz="1100" baseline="-25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AL</a:t>
                      </a:r>
                      <a:endParaRPr lang="de-DE" sz="110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baseline="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  <a:endParaRPr lang="de-DE" sz="110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de-DE" sz="1100" baseline="-25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de-DE" sz="110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</a:tr>
              <a:tr h="2286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nit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gridSpan="4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ol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L]</a:t>
                      </a:r>
                      <a:endParaRPr lang="de-DE" sz="11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gridSpan="3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min</a:t>
                      </a:r>
                      <a:r>
                        <a:rPr lang="en-US" sz="1100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·10</a:t>
                      </a:r>
                      <a:r>
                        <a:rPr lang="en-US" sz="1100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1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[ml/g/min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grid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de-DE" sz="1100" dirty="0" err="1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nity</a:t>
                      </a: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]</a:t>
                      </a: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</a:tr>
              <a:tr h="1682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err="1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stimat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.53</a:t>
                      </a:r>
                      <a:r>
                        <a:rPr lang="de-DE" sz="1100" dirty="0" smtClean="0"/>
                        <a:t> 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5440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V [%]</a:t>
                      </a:r>
                      <a:endParaRPr lang="de-DE" sz="11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4" name="Textfeld 3"/>
          <p:cNvSpPr txBox="1"/>
          <p:nvPr/>
        </p:nvSpPr>
        <p:spPr>
          <a:xfrm>
            <a:off x="360000" y="360000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3</a:t>
            </a:r>
            <a:endParaRPr lang="de-DE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600" y="2209800"/>
            <a:ext cx="5513832" cy="41056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65899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360000" y="360000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3</a:t>
            </a:r>
            <a:endParaRPr lang="de-DE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00" y="720000"/>
            <a:ext cx="8640000" cy="6127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97553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2881473"/>
              </p:ext>
            </p:extLst>
          </p:nvPr>
        </p:nvGraphicFramePr>
        <p:xfrm>
          <a:off x="1080000" y="468000"/>
          <a:ext cx="6826875" cy="81153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37803"/>
                <a:gridCol w="598091"/>
                <a:gridCol w="531416"/>
                <a:gridCol w="640953"/>
                <a:gridCol w="602853"/>
                <a:gridCol w="767953"/>
                <a:gridCol w="648891"/>
                <a:gridCol w="744141"/>
                <a:gridCol w="758428"/>
                <a:gridCol w="311325"/>
                <a:gridCol w="385021"/>
              </a:tblGrid>
              <a:tr h="2286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ameter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1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2,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l-GR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100" baseline="-250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,releas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,releas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λ</a:t>
                      </a:r>
                      <a:r>
                        <a:rPr lang="en-US" sz="1100" baseline="-250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,release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r>
                        <a:rPr lang="de-DE" sz="1100" baseline="-25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AL</a:t>
                      </a:r>
                      <a:endParaRPr lang="de-DE" sz="110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baseline="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100" baseline="-250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  <a:endParaRPr lang="de-DE" sz="110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de-DE" sz="1100" baseline="-25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de-DE" sz="110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/>
                </a:tc>
              </a:tr>
              <a:tr h="2286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nit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gridSpan="4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US" sz="11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ol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L]</a:t>
                      </a:r>
                      <a:endParaRPr lang="de-DE" sz="11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gridSpan="3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min</a:t>
                      </a:r>
                      <a:r>
                        <a:rPr lang="en-US" sz="1100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·10</a:t>
                      </a:r>
                      <a:r>
                        <a:rPr lang="en-US" sz="1100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1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539" marR="58539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[ml/g/min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 grid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de-DE" sz="1100" dirty="0" err="1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nity</a:t>
                      </a: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]</a:t>
                      </a:r>
                    </a:p>
                  </a:txBody>
                  <a:tcPr marL="58539" marR="58539" marT="0" marB="0" anchor="b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</a:tr>
              <a:tr h="1682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de-DE" sz="1100" dirty="0" err="1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stimat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.1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5440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V [%]</a:t>
                      </a:r>
                      <a:endParaRPr lang="de-DE" sz="1100" dirty="0" smtClean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539" marR="58539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4" name="Textfeld 3"/>
          <p:cNvSpPr txBox="1"/>
          <p:nvPr/>
        </p:nvSpPr>
        <p:spPr>
          <a:xfrm>
            <a:off x="360000" y="360000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4</a:t>
            </a:r>
            <a:endParaRPr lang="de-DE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1752600"/>
            <a:ext cx="5931408" cy="48310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36495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360000" y="360000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4</a:t>
            </a:r>
            <a:endParaRPr lang="de-DE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00" y="720000"/>
            <a:ext cx="8640000" cy="6127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42868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6</Words>
  <Application>Microsoft Office PowerPoint</Application>
  <PresentationFormat>Bildschirmpräsentation (4:3)</PresentationFormat>
  <Paragraphs>231</Paragraphs>
  <Slides>1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1</vt:i4>
      </vt:variant>
    </vt:vector>
  </HeadingPairs>
  <TitlesOfParts>
    <vt:vector size="12" baseType="lpstr"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ass, Christian</dc:creator>
  <cp:lastModifiedBy>Kletting Peter</cp:lastModifiedBy>
  <cp:revision>112</cp:revision>
  <dcterms:created xsi:type="dcterms:W3CDTF">2015-07-14T10:54:34Z</dcterms:created>
  <dcterms:modified xsi:type="dcterms:W3CDTF">2016-08-11T10:36:59Z</dcterms:modified>
</cp:coreProperties>
</file>